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E857E-BF15-43F3-801D-4BB6210B97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6B319-CF96-4240-8655-1F2DDF3E2B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6F6DC-945F-4FB8-82C3-DE8388AAFB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BB1FE-AFC5-4B36-B7A8-093B2A03D3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85AA03-53D2-4293-8807-57065DCB72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F97E2-FD7E-49B5-ADF4-337B9A5669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16A151-DBE0-4E5C-BBDB-078A5480CC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90384-6158-4482-BE8A-5FD61F7465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57F74-74BC-492A-AB2D-8C6213C31D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FBA79A-8E58-464D-8F3B-C60448EAC6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0CC05-3E4A-4C5F-8722-4D8F47D547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23E1E5-B34D-4777-9A63-C432012DEC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BC5841-9DCC-4F9B-8A97-2EC7F95880B1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4" descr=""/>
          <p:cNvPicPr/>
          <p:nvPr/>
        </p:nvPicPr>
        <p:blipFill>
          <a:blip r:embed="rId1"/>
          <a:stretch/>
        </p:blipFill>
        <p:spPr>
          <a:xfrm>
            <a:off x="1125360" y="755640"/>
            <a:ext cx="3311640" cy="2330640"/>
          </a:xfrm>
          <a:prstGeom prst="rect">
            <a:avLst/>
          </a:prstGeom>
          <a:ln w="0">
            <a:noFill/>
          </a:ln>
        </p:spPr>
      </p:pic>
      <p:pic>
        <p:nvPicPr>
          <p:cNvPr id="42" name="Grafik 5" descr=""/>
          <p:cNvPicPr/>
          <p:nvPr/>
        </p:nvPicPr>
        <p:blipFill>
          <a:blip r:embed="rId2"/>
          <a:stretch/>
        </p:blipFill>
        <p:spPr>
          <a:xfrm>
            <a:off x="1131840" y="3276720"/>
            <a:ext cx="3305160" cy="2455920"/>
          </a:xfrm>
          <a:prstGeom prst="rect">
            <a:avLst/>
          </a:prstGeom>
          <a:ln w="0">
            <a:noFill/>
          </a:ln>
        </p:spPr>
      </p:pic>
      <p:pic>
        <p:nvPicPr>
          <p:cNvPr id="43" name="Grafik 6" descr=""/>
          <p:cNvPicPr/>
          <p:nvPr/>
        </p:nvPicPr>
        <p:blipFill>
          <a:blip r:embed="rId3"/>
          <a:stretch/>
        </p:blipFill>
        <p:spPr>
          <a:xfrm>
            <a:off x="1131840" y="5954760"/>
            <a:ext cx="3305160" cy="2452680"/>
          </a:xfrm>
          <a:prstGeom prst="rect">
            <a:avLst/>
          </a:prstGeom>
          <a:ln w="0">
            <a:noFill/>
          </a:ln>
        </p:spPr>
      </p:pic>
      <p:sp>
        <p:nvSpPr>
          <p:cNvPr id="44" name="Textfeld 7"/>
          <p:cNvSpPr/>
          <p:nvPr/>
        </p:nvSpPr>
        <p:spPr>
          <a:xfrm>
            <a:off x="719280" y="773280"/>
            <a:ext cx="431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feld 8"/>
          <p:cNvSpPr/>
          <p:nvPr/>
        </p:nvSpPr>
        <p:spPr>
          <a:xfrm>
            <a:off x="719280" y="3271680"/>
            <a:ext cx="431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feld 9"/>
          <p:cNvSpPr/>
          <p:nvPr/>
        </p:nvSpPr>
        <p:spPr>
          <a:xfrm>
            <a:off x="719280" y="5954760"/>
            <a:ext cx="431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feil nach unten 10"/>
          <p:cNvSpPr/>
          <p:nvPr/>
        </p:nvSpPr>
        <p:spPr>
          <a:xfrm>
            <a:off x="3360600" y="6875640"/>
            <a:ext cx="73080" cy="144360"/>
          </a:xfrm>
          <a:prstGeom prst="downArrow">
            <a:avLst>
              <a:gd name="adj1" fmla="val 50000"/>
              <a:gd name="adj2" fmla="val 49384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Pfeil nach unten 11"/>
          <p:cNvSpPr/>
          <p:nvPr/>
        </p:nvSpPr>
        <p:spPr>
          <a:xfrm rot="14571000">
            <a:off x="3688920" y="6601680"/>
            <a:ext cx="71640" cy="144360"/>
          </a:xfrm>
          <a:prstGeom prst="downArrow">
            <a:avLst>
              <a:gd name="adj1" fmla="val 50000"/>
              <a:gd name="adj2" fmla="val 50377"/>
            </a:avLst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feld 1"/>
          <p:cNvSpPr/>
          <p:nvPr/>
        </p:nvSpPr>
        <p:spPr>
          <a:xfrm>
            <a:off x="637920" y="1187280"/>
            <a:ext cx="5238720" cy="222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Calibri"/>
              </a:rPr>
              <a:t>Fig. S1</a:t>
            </a: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: Examples of ALCAM immunostaining in three cervical 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carcinomas showing concomitant cytoplasmic and membraneous 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ALCAM reactivity in tumor cells. A, squamous cell carcinoma 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with weak to moderate ALCAM expression (IRS 4; 400x). B, squamous 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cell carcinoma showing weak to strong ALCAM immunoreactivity 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(IRS 6; 400x). C, squamous cell carcinoma showing moderate to 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strong ALCAM expression (IRS 9) with cytoplasmic and membraneous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staining in varying proportions (200x). Open arrow: mostly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membraneous staining pattern; filled arrow: strong cytoplasmic </a:t>
            </a:r>
            <a:br>
              <a:rPr sz="1400"/>
            </a:br>
            <a:r>
              <a:rPr b="0" lang="de-DE" sz="1400" spc="-1" strike="noStrike">
                <a:solidFill>
                  <a:srgbClr val="000000"/>
                </a:solidFill>
                <a:latin typeface="Calibri"/>
              </a:rPr>
              <a:t>staining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0T09:38:59Z</dcterms:created>
  <dc:creator>K.Milde-Langosch</dc:creator>
  <dc:description/>
  <dc:language>en-US</dc:language>
  <cp:lastModifiedBy> K.Milde-Langosch</cp:lastModifiedBy>
  <dcterms:modified xsi:type="dcterms:W3CDTF">2012-03-21T10:59:45Z</dcterms:modified>
  <cp:revision>5</cp:revision>
  <dc:subject/>
  <dc:title>PowerPoint-Präsentation</dc:title>
</cp:coreProperties>
</file>